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1" d="100"/>
          <a:sy n="61" d="100"/>
        </p:scale>
        <p:origin x="90" y="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0741C1-9A5D-7D93-9F13-40F0F2AE37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7B9D261-BDCB-AE13-41E9-673E044EBB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A5DD832-43D4-63E7-A4E6-F169A2461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4752D02-3390-4F41-2729-F3E22D92A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583353-7CCE-661B-40CD-933994EE4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7301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AADF39-D03B-94A2-519F-CEDD6107C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480218B-1DC4-6C06-BD57-77D22BB084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47A8CC-F058-5E9B-73CE-986EA0005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E06080-E23D-E60A-675C-6913366BB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4F7D91D-B6E9-E0C8-1529-B31810A5B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928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6B02ADB-2E19-9D0D-EA4E-BF9A1D87F2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75C602A-B184-6EF7-C39E-7D4772B618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F735ADF-EE64-F6DC-5FAD-067AB16C1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A22B0E-6E76-5845-7B10-688EB004D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1548B20-E34B-8561-0F4D-5EC166FB7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8831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20B9F5-96CE-2595-937C-7509824046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DCAEC57-8320-B37F-08E2-6562187155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6FE9957-060A-01CF-E02E-911322257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426F55-9218-1728-CAE0-F0C9BAFF6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8CCF419-25F3-9CC5-B487-BA5D07A2D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787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61BF65-E1FE-4B7B-6519-6F2DC8B625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593D19-1965-F882-5F27-AE85E0FB14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273C40-F75E-7F59-EE81-83DC7B332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1A99D17-28FD-BA88-2B0D-442111071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FBB1C3A-2D2A-7B22-BD13-9DE85D0C4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8783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B5A716-C965-CD9F-5DC8-5C1B1A866E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BD4E742-DF7F-E216-8A63-65F55A588C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34C539F-3BAE-EA35-4520-ED7BC09B27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6EAEAE-6C26-32EF-0518-42705BE06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611D20B-7E11-30FE-8421-3B4AF88F4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DDAAFCB-E81D-C2D8-8D8D-01D31B83C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2656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350B8B-4151-23DC-0218-1F01277179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3FFF032-203A-3C1D-3153-092384E511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6F2FC03-A7A1-A804-CB53-52FC54D2EB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A8CEB7F-EAED-DDF2-4C33-712777224E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3960079-3F89-D8EF-D605-E65516F571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05ABA75-6FE4-32BC-820B-ABF8FEA19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73A429A-1C8C-9174-9B99-6571D9C32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CDF7FAC-7511-EFF4-A3DF-9A7951CF3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987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44D6F95-44D6-94BD-2295-05BF0885F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4322074-E489-287C-03E5-EC55A925E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F40C452-F72C-5AA6-9838-BB7307647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834E3E7-983A-268B-4D28-C2A43410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6490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558CD87-3815-AA22-1768-D4C685B47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5A06B35-247E-288A-D009-CD4B33E83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90A2143-F1B0-D117-F1FD-3F165500F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865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375975-B5CC-DDB7-7EAD-DA7BACE64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27AE3BF-1461-D10C-F714-E3BA19C408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462DC25-0940-C28F-5411-45D5872DE0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9AD95F9-9478-0489-8FA3-AB0E05C8B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E9F4B55-127F-BB9C-0107-9487F6F64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1653643-81ED-C0D9-2115-0720EE202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589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9AF93B0-7567-5EF8-A6EC-C5CDECB72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138C223A-BA75-CC74-3BB4-679F28E36E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0920321-F9D1-69A5-172A-785EB9DC40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7E336DF-FA31-1503-4B12-B49F766AB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4C7F9D6-AC86-6CFC-D4CF-8D69CD5E2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0AFB9F-3C8B-7C2C-4175-E0AC377F0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166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E9346B7-8ECF-36CA-51D9-6A5B2B594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983BBAD-FA9F-9BE6-B8AA-8793521D31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E52A7B8-DCAE-363B-9120-4E2B731FFF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C5CA4F-0290-495D-965D-3B7F6D0C2830}" type="datetimeFigureOut">
              <a:rPr lang="fr-FR" smtClean="0"/>
              <a:t>21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210D05-513E-D28E-13A6-D757ED71E9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4509E7B-8A3B-9054-3B7C-C75179E7A3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1B84F-7D1F-4230-B78D-48877E7822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2850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6F3C77F0-82D6-4988-C633-6F41FE99794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70"/>
          <a:stretch/>
        </p:blipFill>
        <p:spPr>
          <a:xfrm>
            <a:off x="6172131" y="1734394"/>
            <a:ext cx="5728423" cy="324651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7AABDB9C-AB27-3E9C-249F-EB3E59592EE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39" r="3271"/>
          <a:stretch/>
        </p:blipFill>
        <p:spPr>
          <a:xfrm>
            <a:off x="296739" y="1734394"/>
            <a:ext cx="5609577" cy="3269237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6533EEE-EC9E-E4D9-7029-9F052A3FD47E}"/>
              </a:ext>
            </a:extLst>
          </p:cNvPr>
          <p:cNvSpPr txBox="1"/>
          <p:nvPr/>
        </p:nvSpPr>
        <p:spPr>
          <a:xfrm>
            <a:off x="475512" y="1282718"/>
            <a:ext cx="405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 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5A2F2B8-4270-BA4E-EFA5-91E2EB1C372D}"/>
              </a:ext>
            </a:extLst>
          </p:cNvPr>
          <p:cNvSpPr txBox="1"/>
          <p:nvPr/>
        </p:nvSpPr>
        <p:spPr>
          <a:xfrm>
            <a:off x="6095999" y="1282718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8191027-7C09-4B69-2BAF-9508A2F3ECF1}"/>
              </a:ext>
            </a:extLst>
          </p:cNvPr>
          <p:cNvSpPr txBox="1"/>
          <p:nvPr/>
        </p:nvSpPr>
        <p:spPr>
          <a:xfrm>
            <a:off x="887002" y="5280757"/>
            <a:ext cx="10835095" cy="2654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1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fr-FR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incipal component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ylsi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man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kin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s</a:t>
            </a:r>
            <a:r>
              <a:rPr lang="fr-FR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NL and L)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se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G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btained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y (a) </a:t>
            </a:r>
            <a:r>
              <a:rPr lang="fr-FR" sz="11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neSpring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(b) LIMMA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i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ference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s</a:t>
            </a:r>
            <a:r>
              <a:rPr lang="fr-FR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</a:p>
        </p:txBody>
      </p:sp>
    </p:spTree>
    <p:extLst>
      <p:ext uri="{BB962C8B-B14F-4D97-AF65-F5344CB8AC3E}">
        <p14:creationId xmlns:p14="http://schemas.microsoft.com/office/powerpoint/2010/main" val="29336445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2</TotalTime>
  <Words>39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4</cp:revision>
  <dcterms:created xsi:type="dcterms:W3CDTF">2023-01-24T10:19:10Z</dcterms:created>
  <dcterms:modified xsi:type="dcterms:W3CDTF">2023-02-21T13:56:09Z</dcterms:modified>
</cp:coreProperties>
</file>